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10645775" cy="139112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002" y="-231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fda.gov\wodc\CFSAN\Users02\Xiugong.Gao\Documents\Project%204%20-%20Toxicogenomics%20of%20AgNPs%20vs%20Ag+%20in%20mESCs\1%20Results\6.%20Supplemental\AgNP%20Characterization\Ag%20concentration_ICP-M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fda.gov\wodc\CFSAN\Users02\Xiugong.Gao\Documents\Project%204%20-%20Toxicogenomics%20of%20AgNPs%20vs%20Ag+%20in%20mESCs\1%20Results\6.%20Supplemental\AgNP%20Characterization\Ag%20concentration_ICP-M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9437546795678753E-2"/>
          <c:y val="3.6105755073298766E-2"/>
          <c:w val="0.94056245320432119"/>
          <c:h val="0.88242545291594643"/>
        </c:manualLayout>
      </c:layout>
      <c:barChart>
        <c:barDir val="col"/>
        <c:grouping val="clustered"/>
        <c:varyColors val="0"/>
        <c:ser>
          <c:idx val="0"/>
          <c:order val="0"/>
          <c:tx>
            <c:v>0 h</c:v>
          </c:tx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AC$6:$AC$9</c:f>
                <c:numCache>
                  <c:formatCode>General</c:formatCode>
                  <c:ptCount val="4"/>
                  <c:pt idx="0">
                    <c:v>2.4856573369157705E-3</c:v>
                  </c:pt>
                  <c:pt idx="1">
                    <c:v>5.6450086886715809E-5</c:v>
                  </c:pt>
                  <c:pt idx="2">
                    <c:v>5.9399038429502164E-3</c:v>
                  </c:pt>
                  <c:pt idx="3">
                    <c:v>1.286996371931272E-2</c:v>
                  </c:pt>
                </c:numCache>
              </c:numRef>
            </c:plus>
            <c:minus>
              <c:numRef>
                <c:f>Sheet1!$AC$6:$AC$9</c:f>
                <c:numCache>
                  <c:formatCode>General</c:formatCode>
                  <c:ptCount val="4"/>
                  <c:pt idx="0">
                    <c:v>2.4856573369157705E-3</c:v>
                  </c:pt>
                  <c:pt idx="1">
                    <c:v>5.6450086886715809E-5</c:v>
                  </c:pt>
                  <c:pt idx="2">
                    <c:v>5.9399038429502164E-3</c:v>
                  </c:pt>
                  <c:pt idx="3">
                    <c:v>1.286996371931272E-2</c:v>
                  </c:pt>
                </c:numCache>
              </c:numRef>
            </c:minus>
          </c:errBars>
          <c:cat>
            <c:numRef>
              <c:f>Sheet1!$Z$6:$Z$9</c:f>
              <c:numCache>
                <c:formatCode>0.0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10</c:v>
                </c:pt>
              </c:numCache>
            </c:numRef>
          </c:cat>
          <c:val>
            <c:numRef>
              <c:f>Sheet1!$AA$6:$AA$9</c:f>
              <c:numCache>
                <c:formatCode>General</c:formatCode>
                <c:ptCount val="4"/>
                <c:pt idx="0">
                  <c:v>5.2203848205028693E-2</c:v>
                </c:pt>
                <c:pt idx="1">
                  <c:v>6.893197689378372E-2</c:v>
                </c:pt>
                <c:pt idx="2">
                  <c:v>9.1309808070687115E-2</c:v>
                </c:pt>
                <c:pt idx="3">
                  <c:v>0.12998385800778875</c:v>
                </c:pt>
              </c:numCache>
            </c:numRef>
          </c:val>
        </c:ser>
        <c:ser>
          <c:idx val="1"/>
          <c:order val="1"/>
          <c:tx>
            <c:v>24 h</c:v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AD$6:$AD$9</c:f>
                <c:numCache>
                  <c:formatCode>General</c:formatCode>
                  <c:ptCount val="4"/>
                  <c:pt idx="0">
                    <c:v>6.8505444531166054E-2</c:v>
                  </c:pt>
                  <c:pt idx="1">
                    <c:v>1.0200754276931748E-3</c:v>
                  </c:pt>
                  <c:pt idx="2">
                    <c:v>1.5782826102692014E-2</c:v>
                  </c:pt>
                  <c:pt idx="3">
                    <c:v>0.21908912748453527</c:v>
                  </c:pt>
                </c:numCache>
              </c:numRef>
            </c:plus>
            <c:minus>
              <c:numRef>
                <c:f>Sheet1!$AD$6:$AD$9</c:f>
                <c:numCache>
                  <c:formatCode>General</c:formatCode>
                  <c:ptCount val="4"/>
                  <c:pt idx="0">
                    <c:v>6.8505444531166054E-2</c:v>
                  </c:pt>
                  <c:pt idx="1">
                    <c:v>1.0200754276931748E-3</c:v>
                  </c:pt>
                  <c:pt idx="2">
                    <c:v>1.5782826102692014E-2</c:v>
                  </c:pt>
                  <c:pt idx="3">
                    <c:v>0.21908912748453527</c:v>
                  </c:pt>
                </c:numCache>
              </c:numRef>
            </c:minus>
          </c:errBars>
          <c:cat>
            <c:numRef>
              <c:f>Sheet1!$Z$6:$Z$9</c:f>
              <c:numCache>
                <c:formatCode>0.0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10</c:v>
                </c:pt>
              </c:numCache>
            </c:numRef>
          </c:cat>
          <c:val>
            <c:numRef>
              <c:f>Sheet1!$AB$6:$AB$9</c:f>
              <c:numCache>
                <c:formatCode>General</c:formatCode>
                <c:ptCount val="4"/>
                <c:pt idx="0">
                  <c:v>0.32640845753739489</c:v>
                </c:pt>
                <c:pt idx="1">
                  <c:v>0.63116839536058322</c:v>
                </c:pt>
                <c:pt idx="2">
                  <c:v>1.0731769170078014</c:v>
                </c:pt>
                <c:pt idx="3">
                  <c:v>1.15143206725601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7591040"/>
        <c:axId val="117605888"/>
      </c:barChart>
      <c:catAx>
        <c:axId val="117591040"/>
        <c:scaling>
          <c:orientation val="minMax"/>
        </c:scaling>
        <c:delete val="0"/>
        <c:axPos val="b"/>
        <c:numFmt formatCode="0.0" sourceLinked="1"/>
        <c:majorTickMark val="none"/>
        <c:minorTickMark val="none"/>
        <c:tickLblPos val="nextTo"/>
        <c:txPr>
          <a:bodyPr/>
          <a:lstStyle/>
          <a:p>
            <a:pPr>
              <a:defRPr baseline="0">
                <a:latin typeface="Arial" panose="020B0604020202020204" pitchFamily="34" charset="0"/>
              </a:defRPr>
            </a:pPr>
            <a:endParaRPr lang="en-US"/>
          </a:p>
        </c:txPr>
        <c:crossAx val="117605888"/>
        <c:crosses val="autoZero"/>
        <c:auto val="1"/>
        <c:lblAlgn val="ctr"/>
        <c:lblOffset val="100"/>
        <c:noMultiLvlLbl val="0"/>
      </c:catAx>
      <c:valAx>
        <c:axId val="117605888"/>
        <c:scaling>
          <c:orientation val="minMax"/>
        </c:scaling>
        <c:delete val="0"/>
        <c:axPos val="l"/>
        <c:majorGridlines>
          <c:spPr>
            <a:ln w="3175">
              <a:prstDash val="dash"/>
            </a:ln>
          </c:spPr>
        </c:majorGridlines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baseline="0">
                <a:latin typeface="Arial" panose="020B0604020202020204" pitchFamily="34" charset="0"/>
              </a:defRPr>
            </a:pPr>
            <a:endParaRPr lang="en-US"/>
          </a:p>
        </c:txPr>
        <c:crossAx val="1175910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6276222416642364"/>
          <c:y val="8.8867745698454362E-2"/>
          <c:w val="0.12085180324681637"/>
          <c:h val="0.10859069699620881"/>
        </c:manualLayout>
      </c:layout>
      <c:overlay val="0"/>
      <c:txPr>
        <a:bodyPr/>
        <a:lstStyle/>
        <a:p>
          <a:pPr>
            <a:defRPr baseline="0">
              <a:latin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1787802225656366E-2"/>
          <c:y val="3.3716475095785438E-2"/>
          <c:w val="0.92821219777434361"/>
          <c:h val="0.88949684737683654"/>
        </c:manualLayout>
      </c:layout>
      <c:barChart>
        <c:barDir val="col"/>
        <c:grouping val="clustered"/>
        <c:varyColors val="0"/>
        <c:ser>
          <c:idx val="0"/>
          <c:order val="0"/>
          <c:tx>
            <c:v>0 h</c:v>
          </c:tx>
          <c:spPr>
            <a:solidFill>
              <a:schemeClr val="bg1">
                <a:lumMod val="8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AC$10:$AC$13</c:f>
                <c:numCache>
                  <c:formatCode>General</c:formatCode>
                  <c:ptCount val="4"/>
                  <c:pt idx="0">
                    <c:v>4.8828483210685281E-3</c:v>
                  </c:pt>
                  <c:pt idx="1">
                    <c:v>2.2926685649256005E-2</c:v>
                  </c:pt>
                  <c:pt idx="2">
                    <c:v>3.8998736041412928E-2</c:v>
                  </c:pt>
                  <c:pt idx="3">
                    <c:v>0.13066864243828016</c:v>
                  </c:pt>
                </c:numCache>
              </c:numRef>
            </c:plus>
            <c:minus>
              <c:numRef>
                <c:f>Sheet1!$AC$10:$AC$13</c:f>
                <c:numCache>
                  <c:formatCode>General</c:formatCode>
                  <c:ptCount val="4"/>
                  <c:pt idx="0">
                    <c:v>4.8828483210685281E-3</c:v>
                  </c:pt>
                  <c:pt idx="1">
                    <c:v>2.2926685649256005E-2</c:v>
                  </c:pt>
                  <c:pt idx="2">
                    <c:v>3.8998736041412928E-2</c:v>
                  </c:pt>
                  <c:pt idx="3">
                    <c:v>0.13066864243828016</c:v>
                  </c:pt>
                </c:numCache>
              </c:numRef>
            </c:minus>
          </c:errBars>
          <c:cat>
            <c:numRef>
              <c:f>Sheet1!$Z$10:$Z$13</c:f>
              <c:numCache>
                <c:formatCode>0.0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10</c:v>
                </c:pt>
              </c:numCache>
            </c:numRef>
          </c:cat>
          <c:val>
            <c:numRef>
              <c:f>Sheet1!$AA$10:$AA$13</c:f>
              <c:numCache>
                <c:formatCode>General</c:formatCode>
                <c:ptCount val="4"/>
                <c:pt idx="0">
                  <c:v>1.0013334391837214</c:v>
                </c:pt>
                <c:pt idx="1">
                  <c:v>2.0830301942678298</c:v>
                </c:pt>
                <c:pt idx="2">
                  <c:v>5.2245252322190625</c:v>
                </c:pt>
                <c:pt idx="3">
                  <c:v>10.494633385727754</c:v>
                </c:pt>
              </c:numCache>
            </c:numRef>
          </c:val>
        </c:ser>
        <c:ser>
          <c:idx val="1"/>
          <c:order val="1"/>
          <c:tx>
            <c:v>24 h</c:v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AD$10:$AD$13</c:f>
                <c:numCache>
                  <c:formatCode>General</c:formatCode>
                  <c:ptCount val="4"/>
                  <c:pt idx="0">
                    <c:v>8.302496852980591E-4</c:v>
                  </c:pt>
                  <c:pt idx="1">
                    <c:v>4.7736821845878628E-3</c:v>
                  </c:pt>
                  <c:pt idx="2">
                    <c:v>3.1277690191756663E-2</c:v>
                  </c:pt>
                  <c:pt idx="3">
                    <c:v>8.2786931138786393E-2</c:v>
                  </c:pt>
                </c:numCache>
              </c:numRef>
            </c:plus>
            <c:minus>
              <c:numRef>
                <c:f>Sheet1!$AD$10:$AD$13</c:f>
                <c:numCache>
                  <c:formatCode>General</c:formatCode>
                  <c:ptCount val="4"/>
                  <c:pt idx="0">
                    <c:v>8.302496852980591E-4</c:v>
                  </c:pt>
                  <c:pt idx="1">
                    <c:v>4.7736821845878628E-3</c:v>
                  </c:pt>
                  <c:pt idx="2">
                    <c:v>3.1277690191756663E-2</c:v>
                  </c:pt>
                  <c:pt idx="3">
                    <c:v>8.2786931138786393E-2</c:v>
                  </c:pt>
                </c:numCache>
              </c:numRef>
            </c:minus>
          </c:errBars>
          <c:cat>
            <c:numRef>
              <c:f>Sheet1!$Z$10:$Z$13</c:f>
              <c:numCache>
                <c:formatCode>0.0</c:formatCode>
                <c:ptCount val="4"/>
                <c:pt idx="0">
                  <c:v>1</c:v>
                </c:pt>
                <c:pt idx="1">
                  <c:v>2</c:v>
                </c:pt>
                <c:pt idx="2">
                  <c:v>5</c:v>
                </c:pt>
                <c:pt idx="3">
                  <c:v>10</c:v>
                </c:pt>
              </c:numCache>
            </c:numRef>
          </c:cat>
          <c:val>
            <c:numRef>
              <c:f>Sheet1!$AB$10:$AB$13</c:f>
              <c:numCache>
                <c:formatCode>General</c:formatCode>
                <c:ptCount val="4"/>
                <c:pt idx="0">
                  <c:v>1.0175012396627636</c:v>
                </c:pt>
                <c:pt idx="1">
                  <c:v>2.0296620989824916</c:v>
                </c:pt>
                <c:pt idx="2">
                  <c:v>5.3423816685317638</c:v>
                </c:pt>
                <c:pt idx="3">
                  <c:v>11.1089170677524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2350592"/>
        <c:axId val="122352384"/>
      </c:barChart>
      <c:catAx>
        <c:axId val="122350592"/>
        <c:scaling>
          <c:orientation val="minMax"/>
        </c:scaling>
        <c:delete val="0"/>
        <c:axPos val="b"/>
        <c:numFmt formatCode="0.0" sourceLinked="1"/>
        <c:majorTickMark val="none"/>
        <c:minorTickMark val="none"/>
        <c:tickLblPos val="nextTo"/>
        <c:txPr>
          <a:bodyPr/>
          <a:lstStyle/>
          <a:p>
            <a:pPr>
              <a:defRPr baseline="0">
                <a:latin typeface="Arial" panose="020B0604020202020204" pitchFamily="34" charset="0"/>
              </a:defRPr>
            </a:pPr>
            <a:endParaRPr lang="en-US"/>
          </a:p>
        </c:txPr>
        <c:crossAx val="122352384"/>
        <c:crosses val="autoZero"/>
        <c:auto val="1"/>
        <c:lblAlgn val="ctr"/>
        <c:lblOffset val="100"/>
        <c:noMultiLvlLbl val="0"/>
      </c:catAx>
      <c:valAx>
        <c:axId val="122352384"/>
        <c:scaling>
          <c:orientation val="minMax"/>
        </c:scaling>
        <c:delete val="0"/>
        <c:axPos val="l"/>
        <c:majorGridlines>
          <c:spPr>
            <a:ln w="3175">
              <a:solidFill>
                <a:schemeClr val="tx1">
                  <a:tint val="75000"/>
                  <a:shade val="95000"/>
                  <a:satMod val="105000"/>
                </a:schemeClr>
              </a:solidFill>
              <a:prstDash val="dash"/>
            </a:ln>
          </c:spPr>
        </c:majorGridlines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baseline="0">
                <a:latin typeface="Arial" panose="020B0604020202020204" pitchFamily="34" charset="0"/>
              </a:defRPr>
            </a:pPr>
            <a:endParaRPr lang="en-US"/>
          </a:p>
        </c:txPr>
        <c:crossAx val="1223505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7356493632740352"/>
          <c:y val="9.246609798775153E-2"/>
          <c:w val="0.11410663944784681"/>
          <c:h val="0.11085310887863155"/>
        </c:manualLayout>
      </c:layout>
      <c:overlay val="0"/>
      <c:txPr>
        <a:bodyPr/>
        <a:lstStyle/>
        <a:p>
          <a:pPr>
            <a:defRPr baseline="0">
              <a:latin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7E929-1641-4886-97DA-4BD6261DFE3B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AB318-412C-47F2-8022-45262393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619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7E929-1641-4886-97DA-4BD6261DFE3B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AB318-412C-47F2-8022-45262393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336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7E929-1641-4886-97DA-4BD6261DFE3B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AB318-412C-47F2-8022-45262393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154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7E929-1641-4886-97DA-4BD6261DFE3B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AB318-412C-47F2-8022-45262393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92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7E929-1641-4886-97DA-4BD6261DFE3B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AB318-412C-47F2-8022-45262393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888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7E929-1641-4886-97DA-4BD6261DFE3B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AB318-412C-47F2-8022-45262393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806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7E929-1641-4886-97DA-4BD6261DFE3B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AB318-412C-47F2-8022-45262393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346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7E929-1641-4886-97DA-4BD6261DFE3B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AB318-412C-47F2-8022-45262393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252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7E929-1641-4886-97DA-4BD6261DFE3B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AB318-412C-47F2-8022-45262393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056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7E929-1641-4886-97DA-4BD6261DFE3B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AB318-412C-47F2-8022-45262393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935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7E929-1641-4886-97DA-4BD6261DFE3B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AB318-412C-47F2-8022-45262393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22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57E929-1641-4886-97DA-4BD6261DFE3B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DAB318-412C-47F2-8022-4526239380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855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-107972" y="2040549"/>
            <a:ext cx="26816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leased Ag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n supernatant (µg/ml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708336" y="3609201"/>
            <a:ext cx="2070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NP concentration (µg/ml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708336" y="7266801"/>
            <a:ext cx="2070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gNP concentration (µg/ml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1066800" y="4996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066800" y="40386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72" name="Chart 7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8805952"/>
              </p:ext>
            </p:extLst>
          </p:nvPr>
        </p:nvGraphicFramePr>
        <p:xfrm>
          <a:off x="1529075" y="818277"/>
          <a:ext cx="41148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8" name="Chart 7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7476730"/>
              </p:ext>
            </p:extLst>
          </p:nvPr>
        </p:nvGraphicFramePr>
        <p:xfrm>
          <a:off x="1551571" y="4422817"/>
          <a:ext cx="41148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1" name="TextBox 80"/>
          <p:cNvSpPr txBox="1"/>
          <p:nvPr/>
        </p:nvSpPr>
        <p:spPr>
          <a:xfrm rot="16200000">
            <a:off x="85699" y="5607252"/>
            <a:ext cx="229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otal Ag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n suspension (µg/ml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85800" y="7671137"/>
            <a:ext cx="5638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Supplementary Figure 1.</a:t>
            </a:r>
            <a:r>
              <a:rPr lang="en-US" sz="1200" dirty="0"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 Release of Ag</a:t>
            </a:r>
            <a:r>
              <a:rPr lang="en-US" sz="1200" baseline="30000" dirty="0"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 from AgNPs into culture medium after 24 h incubation at 37 </a:t>
            </a:r>
            <a:r>
              <a:rPr lang="en-US" sz="1200" dirty="0" smtClean="0"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ºC</a:t>
            </a:r>
            <a:r>
              <a:rPr lang="en-US" sz="1200" dirty="0"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. (A) Ag</a:t>
            </a:r>
            <a:r>
              <a:rPr lang="en-US" sz="1200" baseline="30000" dirty="0"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 released into the supernatant of the medium before (0 h) and after (24 h) incubation. (B) Total Ag</a:t>
            </a:r>
            <a:r>
              <a:rPr lang="en-US" sz="1200" baseline="30000" dirty="0"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 in the AgNP suspension before (0 h) and after (24 h) incubation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03847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8</TotalTime>
  <Words>97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o, Xiugong *</dc:creator>
  <cp:lastModifiedBy>Gao, Xiugong *</cp:lastModifiedBy>
  <cp:revision>22</cp:revision>
  <cp:lastPrinted>2016-01-12T16:28:50Z</cp:lastPrinted>
  <dcterms:created xsi:type="dcterms:W3CDTF">2014-12-08T13:04:02Z</dcterms:created>
  <dcterms:modified xsi:type="dcterms:W3CDTF">2016-11-16T14:13:54Z</dcterms:modified>
</cp:coreProperties>
</file>